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670675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746B3F-2DFD-4873-8432-CEA797C126C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FD6965-45B2-48BD-89B1-02E5C57760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822DF9-97B5-4CFE-9511-0ECE55AE1FC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07E8D0-F476-4496-A332-FC489A18AD7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7933F1-4236-467C-A604-6D66446232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FD0061-6335-4262-9DF5-95D3F24C0D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B81F53-D06B-442F-A040-987784552D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21E48F-5452-4F19-915D-12A8FC283F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018A4F-704F-499B-89EC-211EAA4D10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6F79CE-D5AC-4C3A-B1D8-ABE1CCAEDE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6D94B0-9CB2-48F7-9FEC-3B28B30027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AD2CC2-5F13-42F2-AEDD-D92C87F14C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F4EE59F-2284-4004-BA25-248685A61DE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-146160" y="839880"/>
            <a:ext cx="9374400" cy="4750920"/>
            <a:chOff x="-146160" y="839880"/>
            <a:chExt cx="9374400" cy="4750920"/>
          </a:xfrm>
        </p:grpSpPr>
        <p:sp>
          <p:nvSpPr>
            <p:cNvPr id="42" name=""/>
            <p:cNvSpPr/>
            <p:nvPr/>
          </p:nvSpPr>
          <p:spPr>
            <a:xfrm>
              <a:off x="326880" y="5546880"/>
              <a:ext cx="3812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-34920" y="5375160"/>
              <a:ext cx="1143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k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87280" y="3044880"/>
              <a:ext cx="25884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-146160" y="2873520"/>
              <a:ext cx="1143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k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92240" y="839880"/>
              <a:ext cx="2147760" cy="368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800" spc="-1" strike="noStrike">
                  <a:solidFill>
                    <a:srgbClr val="000000"/>
                  </a:solidFill>
                  <a:latin typeface="Arial"/>
                </a:rPr>
                <a:t>Human FAK gen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8639280" y="149544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3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8688240" y="1812960"/>
              <a:ext cx="540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3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50920" y="2403360"/>
              <a:ext cx="8685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44484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71016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06728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87188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14836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16744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551664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558792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575640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584676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6292800" y="2013120"/>
              <a:ext cx="0" cy="742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632448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644832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649440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651996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673272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679284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686592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691524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694692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705024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713736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7251840" y="2013120"/>
              <a:ext cx="0" cy="742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7558200" y="2013120"/>
              <a:ext cx="0" cy="742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783108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791532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795492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829296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855972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858852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869796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872964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881208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893772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5294160" y="1817640"/>
              <a:ext cx="405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5330880" y="182088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5470560" y="182088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5591160" y="181764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5872320" y="150480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6153120" y="182088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6450120" y="181764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6297480" y="1817640"/>
              <a:ext cx="540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6585120" y="181764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flipH="1">
              <a:off x="6484320" y="150984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6781680" y="1816200"/>
              <a:ext cx="540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6861240" y="151452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7054920" y="151452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7284960" y="1817640"/>
              <a:ext cx="540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7392960" y="150012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7626240" y="1817640"/>
              <a:ext cx="540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7859880" y="149868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8034480" y="181764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8256600" y="181620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8561520" y="181620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3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8489880" y="1498680"/>
              <a:ext cx="540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3595680" y="1817640"/>
              <a:ext cx="206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3317760" y="1816200"/>
              <a:ext cx="206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4753080" y="1822320"/>
              <a:ext cx="206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3946680" y="1817640"/>
              <a:ext cx="206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6313320" y="1508040"/>
              <a:ext cx="540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8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6997680" y="181764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3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1" name=""/>
            <p:cNvGrpSpPr/>
            <p:nvPr/>
          </p:nvGrpSpPr>
          <p:grpSpPr>
            <a:xfrm>
              <a:off x="6795720" y="1644480"/>
              <a:ext cx="119160" cy="300240"/>
              <a:chOff x="6795720" y="1644480"/>
              <a:chExt cx="119160" cy="300240"/>
            </a:xfrm>
          </p:grpSpPr>
          <p:sp>
            <p:nvSpPr>
              <p:cNvPr id="112" name=""/>
              <p:cNvSpPr/>
              <p:nvPr/>
            </p:nvSpPr>
            <p:spPr>
              <a:xfrm flipV="1">
                <a:off x="6914880" y="1728720"/>
                <a:ext cx="0" cy="21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 flipH="1" flipV="1">
                <a:off x="6795720" y="1644480"/>
                <a:ext cx="11916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4" name=""/>
            <p:cNvGrpSpPr/>
            <p:nvPr/>
          </p:nvGrpSpPr>
          <p:grpSpPr>
            <a:xfrm>
              <a:off x="8588520" y="1638000"/>
              <a:ext cx="118800" cy="299520"/>
              <a:chOff x="8588520" y="1638000"/>
              <a:chExt cx="118800" cy="299520"/>
            </a:xfrm>
          </p:grpSpPr>
          <p:sp>
            <p:nvSpPr>
              <p:cNvPr id="115" name=""/>
              <p:cNvSpPr/>
              <p:nvPr/>
            </p:nvSpPr>
            <p:spPr>
              <a:xfrm flipV="1">
                <a:off x="8588520" y="1721880"/>
                <a:ext cx="0" cy="21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 flipV="1">
                <a:off x="8588520" y="1638000"/>
                <a:ext cx="118800" cy="7740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7" name=""/>
            <p:cNvGrpSpPr/>
            <p:nvPr/>
          </p:nvGrpSpPr>
          <p:grpSpPr>
            <a:xfrm>
              <a:off x="8732880" y="1636560"/>
              <a:ext cx="119160" cy="300240"/>
              <a:chOff x="8732880" y="1636560"/>
              <a:chExt cx="119160" cy="300240"/>
            </a:xfrm>
          </p:grpSpPr>
          <p:sp>
            <p:nvSpPr>
              <p:cNvPr id="118" name=""/>
              <p:cNvSpPr/>
              <p:nvPr/>
            </p:nvSpPr>
            <p:spPr>
              <a:xfrm flipV="1">
                <a:off x="8732880" y="1720800"/>
                <a:ext cx="0" cy="21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 flipV="1">
                <a:off x="8732880" y="1636560"/>
                <a:ext cx="11916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0" name=""/>
            <p:cNvGrpSpPr/>
            <p:nvPr/>
          </p:nvGrpSpPr>
          <p:grpSpPr>
            <a:xfrm>
              <a:off x="7961400" y="1638000"/>
              <a:ext cx="118800" cy="299520"/>
              <a:chOff x="7961400" y="1638000"/>
              <a:chExt cx="118800" cy="299520"/>
            </a:xfrm>
          </p:grpSpPr>
          <p:sp>
            <p:nvSpPr>
              <p:cNvPr id="121" name=""/>
              <p:cNvSpPr/>
              <p:nvPr/>
            </p:nvSpPr>
            <p:spPr>
              <a:xfrm flipV="1">
                <a:off x="7961400" y="1721880"/>
                <a:ext cx="0" cy="21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 flipV="1">
                <a:off x="7961400" y="1638000"/>
                <a:ext cx="118800" cy="7740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3" name=""/>
            <p:cNvGrpSpPr/>
            <p:nvPr/>
          </p:nvGrpSpPr>
          <p:grpSpPr>
            <a:xfrm>
              <a:off x="3340080" y="1257480"/>
              <a:ext cx="1244520" cy="558720"/>
              <a:chOff x="3340080" y="1257480"/>
              <a:chExt cx="1244520" cy="558720"/>
            </a:xfrm>
          </p:grpSpPr>
          <p:sp>
            <p:nvSpPr>
              <p:cNvPr id="124" name=""/>
              <p:cNvSpPr/>
              <p:nvPr/>
            </p:nvSpPr>
            <p:spPr>
              <a:xfrm>
                <a:off x="3438360" y="1509840"/>
                <a:ext cx="0" cy="30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3340080" y="1257480"/>
                <a:ext cx="1244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FAK-ATG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6" name=""/>
            <p:cNvGrpSpPr/>
            <p:nvPr/>
          </p:nvGrpSpPr>
          <p:grpSpPr>
            <a:xfrm>
              <a:off x="7440480" y="1266840"/>
              <a:ext cx="1244880" cy="558720"/>
              <a:chOff x="7440480" y="1266840"/>
              <a:chExt cx="1244880" cy="558720"/>
            </a:xfrm>
          </p:grpSpPr>
          <p:sp>
            <p:nvSpPr>
              <p:cNvPr id="127" name=""/>
              <p:cNvSpPr/>
              <p:nvPr/>
            </p:nvSpPr>
            <p:spPr>
              <a:xfrm>
                <a:off x="7539120" y="1519200"/>
                <a:ext cx="0" cy="30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7440480" y="1266840"/>
                <a:ext cx="1244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FRNK-ATG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9" name=""/>
            <p:cNvGrpSpPr/>
            <p:nvPr/>
          </p:nvGrpSpPr>
          <p:grpSpPr>
            <a:xfrm>
              <a:off x="5975280" y="1817640"/>
              <a:ext cx="539640" cy="200520"/>
              <a:chOff x="5975280" y="1817640"/>
              <a:chExt cx="539640" cy="200520"/>
            </a:xfrm>
          </p:grpSpPr>
          <p:sp>
            <p:nvSpPr>
              <p:cNvPr id="130" name=""/>
              <p:cNvSpPr/>
              <p:nvPr/>
            </p:nvSpPr>
            <p:spPr>
              <a:xfrm>
                <a:off x="5975280" y="1817640"/>
                <a:ext cx="5396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</a:rPr>
                  <a:t>1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6190920" y="1861920"/>
                <a:ext cx="117720" cy="1080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2" name=""/>
            <p:cNvSpPr/>
            <p:nvPr/>
          </p:nvSpPr>
          <p:spPr>
            <a:xfrm>
              <a:off x="6083280" y="1549440"/>
              <a:ext cx="117360" cy="1080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6505560" y="1552680"/>
              <a:ext cx="160200" cy="1080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7175520" y="1865160"/>
              <a:ext cx="179280" cy="1080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5" name=""/>
            <p:cNvGrpSpPr/>
            <p:nvPr/>
          </p:nvGrpSpPr>
          <p:grpSpPr>
            <a:xfrm>
              <a:off x="7710120" y="1639800"/>
              <a:ext cx="119160" cy="300240"/>
              <a:chOff x="7710120" y="1639800"/>
              <a:chExt cx="119160" cy="300240"/>
            </a:xfrm>
          </p:grpSpPr>
          <p:sp>
            <p:nvSpPr>
              <p:cNvPr id="136" name=""/>
              <p:cNvSpPr/>
              <p:nvPr/>
            </p:nvSpPr>
            <p:spPr>
              <a:xfrm flipV="1">
                <a:off x="7829280" y="1724040"/>
                <a:ext cx="0" cy="21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 flipH="1" flipV="1">
                <a:off x="7710120" y="1639800"/>
                <a:ext cx="11916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8" name=""/>
            <p:cNvGrpSpPr/>
            <p:nvPr/>
          </p:nvGrpSpPr>
          <p:grpSpPr>
            <a:xfrm>
              <a:off x="7140600" y="1649160"/>
              <a:ext cx="119160" cy="299520"/>
              <a:chOff x="7140600" y="1649160"/>
              <a:chExt cx="119160" cy="299520"/>
            </a:xfrm>
          </p:grpSpPr>
          <p:sp>
            <p:nvSpPr>
              <p:cNvPr id="139" name=""/>
              <p:cNvSpPr/>
              <p:nvPr/>
            </p:nvSpPr>
            <p:spPr>
              <a:xfrm flipV="1">
                <a:off x="7140600" y="1733040"/>
                <a:ext cx="0" cy="21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 flipV="1">
                <a:off x="7140600" y="1649160"/>
                <a:ext cx="119160" cy="7740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1" name=""/>
            <p:cNvGrpSpPr/>
            <p:nvPr/>
          </p:nvGrpSpPr>
          <p:grpSpPr>
            <a:xfrm>
              <a:off x="6953400" y="1649160"/>
              <a:ext cx="118800" cy="299520"/>
              <a:chOff x="6953400" y="1649160"/>
              <a:chExt cx="118800" cy="299520"/>
            </a:xfrm>
          </p:grpSpPr>
          <p:sp>
            <p:nvSpPr>
              <p:cNvPr id="142" name=""/>
              <p:cNvSpPr/>
              <p:nvPr/>
            </p:nvSpPr>
            <p:spPr>
              <a:xfrm flipV="1">
                <a:off x="6953400" y="1733040"/>
                <a:ext cx="0" cy="21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 flipV="1">
                <a:off x="6953400" y="1649160"/>
                <a:ext cx="118800" cy="7740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4" name=""/>
            <p:cNvGrpSpPr/>
            <p:nvPr/>
          </p:nvGrpSpPr>
          <p:grpSpPr>
            <a:xfrm>
              <a:off x="6673320" y="1649160"/>
              <a:ext cx="119160" cy="299520"/>
              <a:chOff x="6673320" y="1649160"/>
              <a:chExt cx="119160" cy="299520"/>
            </a:xfrm>
          </p:grpSpPr>
          <p:sp>
            <p:nvSpPr>
              <p:cNvPr id="145" name=""/>
              <p:cNvSpPr/>
              <p:nvPr/>
            </p:nvSpPr>
            <p:spPr>
              <a:xfrm flipV="1">
                <a:off x="6792480" y="1733040"/>
                <a:ext cx="0" cy="21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 flipH="1" flipV="1">
                <a:off x="6673320" y="1649160"/>
                <a:ext cx="119160" cy="7740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7" name=""/>
            <p:cNvGrpSpPr/>
            <p:nvPr/>
          </p:nvGrpSpPr>
          <p:grpSpPr>
            <a:xfrm>
              <a:off x="6066000" y="1503360"/>
              <a:ext cx="539640" cy="435600"/>
              <a:chOff x="6066000" y="1503360"/>
              <a:chExt cx="539640" cy="435600"/>
            </a:xfrm>
          </p:grpSpPr>
          <p:grpSp>
            <p:nvGrpSpPr>
              <p:cNvPr id="148" name=""/>
              <p:cNvGrpSpPr/>
              <p:nvPr/>
            </p:nvGrpSpPr>
            <p:grpSpPr>
              <a:xfrm>
                <a:off x="6066000" y="1503360"/>
                <a:ext cx="539640" cy="200520"/>
                <a:chOff x="6066000" y="1503360"/>
                <a:chExt cx="539640" cy="200520"/>
              </a:xfrm>
            </p:grpSpPr>
            <p:sp>
              <p:nvSpPr>
                <p:cNvPr id="149" name=""/>
                <p:cNvSpPr/>
                <p:nvPr/>
              </p:nvSpPr>
              <p:spPr>
                <a:xfrm>
                  <a:off x="6066000" y="1503360"/>
                  <a:ext cx="53964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</a:rPr>
                    <a:t>16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"/>
                <p:cNvSpPr/>
                <p:nvPr/>
              </p:nvSpPr>
              <p:spPr>
                <a:xfrm>
                  <a:off x="6274080" y="1549440"/>
                  <a:ext cx="117360" cy="10764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51" name=""/>
              <p:cNvGrpSpPr/>
              <p:nvPr/>
            </p:nvGrpSpPr>
            <p:grpSpPr>
              <a:xfrm>
                <a:off x="6379920" y="1639440"/>
                <a:ext cx="118440" cy="299520"/>
                <a:chOff x="6379920" y="1639440"/>
                <a:chExt cx="118440" cy="299520"/>
              </a:xfrm>
            </p:grpSpPr>
            <p:sp>
              <p:nvSpPr>
                <p:cNvPr id="152" name=""/>
                <p:cNvSpPr/>
                <p:nvPr/>
              </p:nvSpPr>
              <p:spPr>
                <a:xfrm flipV="1">
                  <a:off x="6498360" y="1723320"/>
                  <a:ext cx="0" cy="215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"/>
                <p:cNvSpPr/>
                <p:nvPr/>
              </p:nvSpPr>
              <p:spPr>
                <a:xfrm flipH="1" flipV="1">
                  <a:off x="6379920" y="1639440"/>
                  <a:ext cx="118440" cy="774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0600" bIns="30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54" name=""/>
            <p:cNvGrpSpPr/>
            <p:nvPr/>
          </p:nvGrpSpPr>
          <p:grpSpPr>
            <a:xfrm>
              <a:off x="6213600" y="1639800"/>
              <a:ext cx="118800" cy="300240"/>
              <a:chOff x="6213600" y="1639800"/>
              <a:chExt cx="118800" cy="300240"/>
            </a:xfrm>
          </p:grpSpPr>
          <p:sp>
            <p:nvSpPr>
              <p:cNvPr id="155" name=""/>
              <p:cNvSpPr/>
              <p:nvPr/>
            </p:nvSpPr>
            <p:spPr>
              <a:xfrm flipV="1">
                <a:off x="6332400" y="1724040"/>
                <a:ext cx="0" cy="21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 flipH="1" flipV="1">
                <a:off x="6213600" y="1639800"/>
                <a:ext cx="11880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57" name=""/>
            <p:cNvSpPr/>
            <p:nvPr/>
          </p:nvSpPr>
          <p:spPr>
            <a:xfrm>
              <a:off x="4897440" y="1530360"/>
              <a:ext cx="206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8" name=""/>
            <p:cNvGrpSpPr/>
            <p:nvPr/>
          </p:nvGrpSpPr>
          <p:grpSpPr>
            <a:xfrm>
              <a:off x="5025960" y="1533600"/>
              <a:ext cx="393480" cy="427680"/>
              <a:chOff x="5025960" y="1533600"/>
              <a:chExt cx="393480" cy="427680"/>
            </a:xfrm>
          </p:grpSpPr>
          <p:sp>
            <p:nvSpPr>
              <p:cNvPr id="159" name=""/>
              <p:cNvSpPr/>
              <p:nvPr/>
            </p:nvSpPr>
            <p:spPr>
              <a:xfrm>
                <a:off x="5214600" y="1533600"/>
                <a:ext cx="2048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</a:rPr>
                  <a:t>8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60" name=""/>
              <p:cNvGrpSpPr/>
              <p:nvPr/>
            </p:nvGrpSpPr>
            <p:grpSpPr>
              <a:xfrm>
                <a:off x="5171760" y="1661760"/>
                <a:ext cx="119160" cy="299520"/>
                <a:chOff x="5171760" y="1661760"/>
                <a:chExt cx="119160" cy="299520"/>
              </a:xfrm>
            </p:grpSpPr>
            <p:sp>
              <p:nvSpPr>
                <p:cNvPr id="161" name=""/>
                <p:cNvSpPr/>
                <p:nvPr/>
              </p:nvSpPr>
              <p:spPr>
                <a:xfrm flipV="1">
                  <a:off x="5171760" y="1746000"/>
                  <a:ext cx="0" cy="215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"/>
                <p:cNvSpPr/>
                <p:nvPr/>
              </p:nvSpPr>
              <p:spPr>
                <a:xfrm flipV="1">
                  <a:off x="5171760" y="1661760"/>
                  <a:ext cx="119160" cy="774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0600" bIns="30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63" name=""/>
              <p:cNvGrpSpPr/>
              <p:nvPr/>
            </p:nvGrpSpPr>
            <p:grpSpPr>
              <a:xfrm>
                <a:off x="5025960" y="1659960"/>
                <a:ext cx="118800" cy="299520"/>
                <a:chOff x="5025960" y="1659960"/>
                <a:chExt cx="118800" cy="299520"/>
              </a:xfrm>
            </p:grpSpPr>
            <p:sp>
              <p:nvSpPr>
                <p:cNvPr id="164" name=""/>
                <p:cNvSpPr/>
                <p:nvPr/>
              </p:nvSpPr>
              <p:spPr>
                <a:xfrm flipV="1">
                  <a:off x="5144760" y="1743840"/>
                  <a:ext cx="0" cy="215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"/>
                <p:cNvSpPr/>
                <p:nvPr/>
              </p:nvSpPr>
              <p:spPr>
                <a:xfrm flipH="1" flipV="1">
                  <a:off x="5025960" y="1659960"/>
                  <a:ext cx="118800" cy="774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0600" bIns="30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66" name=""/>
            <p:cNvGrpSpPr/>
            <p:nvPr/>
          </p:nvGrpSpPr>
          <p:grpSpPr>
            <a:xfrm>
              <a:off x="4219560" y="1514520"/>
              <a:ext cx="523440" cy="432360"/>
              <a:chOff x="4219560" y="1514520"/>
              <a:chExt cx="523440" cy="432360"/>
            </a:xfrm>
          </p:grpSpPr>
          <p:sp>
            <p:nvSpPr>
              <p:cNvPr id="167" name=""/>
              <p:cNvSpPr/>
              <p:nvPr/>
            </p:nvSpPr>
            <p:spPr>
              <a:xfrm>
                <a:off x="4219560" y="1515960"/>
                <a:ext cx="2062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68" name=""/>
              <p:cNvGrpSpPr/>
              <p:nvPr/>
            </p:nvGrpSpPr>
            <p:grpSpPr>
              <a:xfrm>
                <a:off x="4512960" y="1647360"/>
                <a:ext cx="118800" cy="299520"/>
                <a:chOff x="4512960" y="1647360"/>
                <a:chExt cx="118800" cy="299520"/>
              </a:xfrm>
            </p:grpSpPr>
            <p:sp>
              <p:nvSpPr>
                <p:cNvPr id="169" name=""/>
                <p:cNvSpPr/>
                <p:nvPr/>
              </p:nvSpPr>
              <p:spPr>
                <a:xfrm flipV="1">
                  <a:off x="4512960" y="1731240"/>
                  <a:ext cx="0" cy="215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0" name=""/>
                <p:cNvSpPr/>
                <p:nvPr/>
              </p:nvSpPr>
              <p:spPr>
                <a:xfrm flipV="1">
                  <a:off x="4512960" y="1647360"/>
                  <a:ext cx="118800" cy="774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0600" bIns="30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71" name=""/>
              <p:cNvGrpSpPr/>
              <p:nvPr/>
            </p:nvGrpSpPr>
            <p:grpSpPr>
              <a:xfrm>
                <a:off x="4366800" y="1645920"/>
                <a:ext cx="118440" cy="299520"/>
                <a:chOff x="4366800" y="1645920"/>
                <a:chExt cx="118440" cy="299520"/>
              </a:xfrm>
            </p:grpSpPr>
            <p:sp>
              <p:nvSpPr>
                <p:cNvPr id="172" name=""/>
                <p:cNvSpPr/>
                <p:nvPr/>
              </p:nvSpPr>
              <p:spPr>
                <a:xfrm flipV="1">
                  <a:off x="4485240" y="1729800"/>
                  <a:ext cx="0" cy="215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3" name=""/>
                <p:cNvSpPr/>
                <p:nvPr/>
              </p:nvSpPr>
              <p:spPr>
                <a:xfrm flipH="1" flipV="1">
                  <a:off x="4366800" y="1645920"/>
                  <a:ext cx="118440" cy="774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0600" bIns="30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74" name=""/>
              <p:cNvSpPr/>
              <p:nvPr/>
            </p:nvSpPr>
            <p:spPr>
              <a:xfrm>
                <a:off x="4536720" y="1514520"/>
                <a:ext cx="2062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5" name=""/>
            <p:cNvGrpSpPr/>
            <p:nvPr/>
          </p:nvGrpSpPr>
          <p:grpSpPr>
            <a:xfrm>
              <a:off x="4489560" y="2009880"/>
              <a:ext cx="19080" cy="744480"/>
              <a:chOff x="4489560" y="2009880"/>
              <a:chExt cx="19080" cy="744480"/>
            </a:xfrm>
          </p:grpSpPr>
          <p:sp>
            <p:nvSpPr>
              <p:cNvPr id="176" name=""/>
              <p:cNvSpPr/>
              <p:nvPr/>
            </p:nvSpPr>
            <p:spPr>
              <a:xfrm>
                <a:off x="4489560" y="2009880"/>
                <a:ext cx="0" cy="744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4508640" y="2009880"/>
                <a:ext cx="0" cy="744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8" name=""/>
            <p:cNvSpPr/>
            <p:nvPr/>
          </p:nvSpPr>
          <p:spPr>
            <a:xfrm>
              <a:off x="2655720" y="200988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2540160" y="200988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2435400" y="1822320"/>
              <a:ext cx="431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-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2305080" y="1822320"/>
              <a:ext cx="431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-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593640" y="200988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1695600" y="20145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1474920" y="1817640"/>
              <a:ext cx="431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-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164880" y="2041560"/>
              <a:ext cx="4352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…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376200" y="1816200"/>
              <a:ext cx="432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-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192240" y="3446640"/>
              <a:ext cx="2147760" cy="368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800" spc="-1" strike="noStrike">
                  <a:solidFill>
                    <a:srgbClr val="000000"/>
                  </a:solidFill>
                  <a:latin typeface="Arial"/>
                </a:rPr>
                <a:t>Mouse FAK gen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237960" y="4862520"/>
              <a:ext cx="8609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408924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449280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467208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522936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541512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543564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563076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568476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572760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584532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6145200" y="4503600"/>
              <a:ext cx="0" cy="712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618804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637236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641988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645480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665316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674532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681048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687240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697536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706284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756936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7790040" y="4503600"/>
              <a:ext cx="0" cy="712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7935840" y="4503600"/>
              <a:ext cx="0" cy="712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801684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830268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848844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850572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864540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868680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873288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8845560" y="450540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4822920" y="4503600"/>
              <a:ext cx="0" cy="714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4843440" y="4503600"/>
              <a:ext cx="0" cy="714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3435480" y="451332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3267000" y="4311720"/>
              <a:ext cx="301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-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3249720" y="450864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1846440" y="450864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622440" y="451332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180720" y="4498920"/>
              <a:ext cx="4352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…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8861400" y="4003560"/>
              <a:ext cx="30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3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5427720" y="4313160"/>
              <a:ext cx="404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5273640" y="4309920"/>
              <a:ext cx="206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4764240" y="4314960"/>
              <a:ext cx="204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4678200" y="4313160"/>
              <a:ext cx="206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5562720" y="399888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5477040" y="431316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5737320" y="399888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5830920" y="430992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6067440" y="430992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6381720" y="431316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6224760" y="430992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6543720" y="431316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6702480" y="431496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7297560" y="4313160"/>
              <a:ext cx="540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7513560" y="4313160"/>
              <a:ext cx="540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7756560" y="431316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8037360" y="4319640"/>
              <a:ext cx="540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8178840" y="431784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8485200" y="431784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3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3968640" y="4313160"/>
              <a:ext cx="206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5108400" y="4313160"/>
              <a:ext cx="206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8709120" y="4003560"/>
              <a:ext cx="304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3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52" name=""/>
            <p:cNvGrpSpPr/>
            <p:nvPr/>
          </p:nvGrpSpPr>
          <p:grpSpPr>
            <a:xfrm>
              <a:off x="5678640" y="4135320"/>
              <a:ext cx="118800" cy="300240"/>
              <a:chOff x="5678640" y="4135320"/>
              <a:chExt cx="118800" cy="300240"/>
            </a:xfrm>
          </p:grpSpPr>
          <p:sp>
            <p:nvSpPr>
              <p:cNvPr id="253" name=""/>
              <p:cNvSpPr/>
              <p:nvPr/>
            </p:nvSpPr>
            <p:spPr>
              <a:xfrm flipV="1">
                <a:off x="5678640" y="4219560"/>
                <a:ext cx="0" cy="21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"/>
              <p:cNvSpPr/>
              <p:nvPr/>
            </p:nvSpPr>
            <p:spPr>
              <a:xfrm flipV="1">
                <a:off x="5678640" y="4135320"/>
                <a:ext cx="11880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55" name=""/>
            <p:cNvGrpSpPr/>
            <p:nvPr/>
          </p:nvGrpSpPr>
          <p:grpSpPr>
            <a:xfrm>
              <a:off x="5846760" y="4133520"/>
              <a:ext cx="119160" cy="299520"/>
              <a:chOff x="5846760" y="4133520"/>
              <a:chExt cx="119160" cy="299520"/>
            </a:xfrm>
          </p:grpSpPr>
          <p:sp>
            <p:nvSpPr>
              <p:cNvPr id="256" name=""/>
              <p:cNvSpPr/>
              <p:nvPr/>
            </p:nvSpPr>
            <p:spPr>
              <a:xfrm flipV="1">
                <a:off x="5846760" y="4217400"/>
                <a:ext cx="0" cy="21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"/>
              <p:cNvSpPr/>
              <p:nvPr/>
            </p:nvSpPr>
            <p:spPr>
              <a:xfrm flipV="1">
                <a:off x="5846760" y="4133520"/>
                <a:ext cx="119160" cy="7740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58" name=""/>
            <p:cNvGrpSpPr/>
            <p:nvPr/>
          </p:nvGrpSpPr>
          <p:grpSpPr>
            <a:xfrm>
              <a:off x="6624720" y="3998880"/>
              <a:ext cx="539640" cy="435600"/>
              <a:chOff x="6624720" y="3998880"/>
              <a:chExt cx="539640" cy="435600"/>
            </a:xfrm>
          </p:grpSpPr>
          <p:sp>
            <p:nvSpPr>
              <p:cNvPr id="259" name=""/>
              <p:cNvSpPr/>
              <p:nvPr/>
            </p:nvSpPr>
            <p:spPr>
              <a:xfrm>
                <a:off x="6624720" y="3998880"/>
                <a:ext cx="5396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</a:rPr>
                  <a:t>19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60" name=""/>
              <p:cNvGrpSpPr/>
              <p:nvPr/>
            </p:nvGrpSpPr>
            <p:grpSpPr>
              <a:xfrm>
                <a:off x="6745320" y="4134960"/>
                <a:ext cx="119160" cy="299520"/>
                <a:chOff x="6745320" y="4134960"/>
                <a:chExt cx="119160" cy="299520"/>
              </a:xfrm>
            </p:grpSpPr>
            <p:sp>
              <p:nvSpPr>
                <p:cNvPr id="261" name=""/>
                <p:cNvSpPr/>
                <p:nvPr/>
              </p:nvSpPr>
              <p:spPr>
                <a:xfrm flipV="1">
                  <a:off x="6745320" y="4218840"/>
                  <a:ext cx="0" cy="215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2" name=""/>
                <p:cNvSpPr/>
                <p:nvPr/>
              </p:nvSpPr>
              <p:spPr>
                <a:xfrm flipV="1">
                  <a:off x="6745320" y="4134960"/>
                  <a:ext cx="119160" cy="774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0600" bIns="30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263" name=""/>
            <p:cNvGrpSpPr/>
            <p:nvPr/>
          </p:nvGrpSpPr>
          <p:grpSpPr>
            <a:xfrm>
              <a:off x="6786720" y="4003560"/>
              <a:ext cx="539640" cy="434880"/>
              <a:chOff x="6786720" y="4003560"/>
              <a:chExt cx="539640" cy="434880"/>
            </a:xfrm>
          </p:grpSpPr>
          <p:sp>
            <p:nvSpPr>
              <p:cNvPr id="264" name=""/>
              <p:cNvSpPr/>
              <p:nvPr/>
            </p:nvSpPr>
            <p:spPr>
              <a:xfrm>
                <a:off x="6786720" y="4003560"/>
                <a:ext cx="5396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</a:rPr>
                  <a:t>2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65" name=""/>
              <p:cNvGrpSpPr/>
              <p:nvPr/>
            </p:nvGrpSpPr>
            <p:grpSpPr>
              <a:xfrm>
                <a:off x="6878520" y="4138200"/>
                <a:ext cx="119160" cy="300240"/>
                <a:chOff x="6878520" y="4138200"/>
                <a:chExt cx="119160" cy="300240"/>
              </a:xfrm>
            </p:grpSpPr>
            <p:sp>
              <p:nvSpPr>
                <p:cNvPr id="266" name=""/>
                <p:cNvSpPr/>
                <p:nvPr/>
              </p:nvSpPr>
              <p:spPr>
                <a:xfrm flipV="1">
                  <a:off x="6878520" y="4222440"/>
                  <a:ext cx="0" cy="2160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7" name=""/>
                <p:cNvSpPr/>
                <p:nvPr/>
              </p:nvSpPr>
              <p:spPr>
                <a:xfrm flipV="1">
                  <a:off x="6878520" y="4138200"/>
                  <a:ext cx="119160" cy="777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0960" bIns="30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268" name=""/>
            <p:cNvGrpSpPr/>
            <p:nvPr/>
          </p:nvGrpSpPr>
          <p:grpSpPr>
            <a:xfrm>
              <a:off x="6975360" y="4003560"/>
              <a:ext cx="540000" cy="435240"/>
              <a:chOff x="6975360" y="4003560"/>
              <a:chExt cx="540000" cy="435240"/>
            </a:xfrm>
          </p:grpSpPr>
          <p:sp>
            <p:nvSpPr>
              <p:cNvPr id="269" name=""/>
              <p:cNvSpPr/>
              <p:nvPr/>
            </p:nvSpPr>
            <p:spPr>
              <a:xfrm>
                <a:off x="6975360" y="4003560"/>
                <a:ext cx="540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</a:rPr>
                  <a:t>2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70" name=""/>
              <p:cNvGrpSpPr/>
              <p:nvPr/>
            </p:nvGrpSpPr>
            <p:grpSpPr>
              <a:xfrm>
                <a:off x="7059600" y="4138560"/>
                <a:ext cx="119160" cy="300240"/>
                <a:chOff x="7059600" y="4138560"/>
                <a:chExt cx="119160" cy="300240"/>
              </a:xfrm>
            </p:grpSpPr>
            <p:sp>
              <p:nvSpPr>
                <p:cNvPr id="271" name=""/>
                <p:cNvSpPr/>
                <p:nvPr/>
              </p:nvSpPr>
              <p:spPr>
                <a:xfrm flipV="1">
                  <a:off x="7059600" y="4222800"/>
                  <a:ext cx="0" cy="2160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2" name=""/>
                <p:cNvSpPr/>
                <p:nvPr/>
              </p:nvSpPr>
              <p:spPr>
                <a:xfrm flipV="1">
                  <a:off x="7059600" y="4138560"/>
                  <a:ext cx="119160" cy="777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0960" bIns="30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273" name=""/>
            <p:cNvGrpSpPr/>
            <p:nvPr/>
          </p:nvGrpSpPr>
          <p:grpSpPr>
            <a:xfrm>
              <a:off x="7839000" y="4000680"/>
              <a:ext cx="540000" cy="434160"/>
              <a:chOff x="7839000" y="4000680"/>
              <a:chExt cx="540000" cy="434160"/>
            </a:xfrm>
          </p:grpSpPr>
          <p:sp>
            <p:nvSpPr>
              <p:cNvPr id="274" name=""/>
              <p:cNvSpPr/>
              <p:nvPr/>
            </p:nvSpPr>
            <p:spPr>
              <a:xfrm>
                <a:off x="7839000" y="4000680"/>
                <a:ext cx="540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</a:rPr>
                  <a:t>26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75" name=""/>
              <p:cNvGrpSpPr/>
              <p:nvPr/>
            </p:nvGrpSpPr>
            <p:grpSpPr>
              <a:xfrm>
                <a:off x="7934400" y="4135320"/>
                <a:ext cx="119160" cy="299520"/>
                <a:chOff x="7934400" y="4135320"/>
                <a:chExt cx="119160" cy="299520"/>
              </a:xfrm>
            </p:grpSpPr>
            <p:sp>
              <p:nvSpPr>
                <p:cNvPr id="276" name=""/>
                <p:cNvSpPr/>
                <p:nvPr/>
              </p:nvSpPr>
              <p:spPr>
                <a:xfrm flipV="1">
                  <a:off x="7934400" y="4219200"/>
                  <a:ext cx="0" cy="215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7" name=""/>
                <p:cNvSpPr/>
                <p:nvPr/>
              </p:nvSpPr>
              <p:spPr>
                <a:xfrm flipV="1">
                  <a:off x="7934400" y="4135320"/>
                  <a:ext cx="119160" cy="774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0600" bIns="30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278" name=""/>
            <p:cNvGrpSpPr/>
            <p:nvPr/>
          </p:nvGrpSpPr>
          <p:grpSpPr>
            <a:xfrm>
              <a:off x="8413920" y="4003560"/>
              <a:ext cx="539640" cy="430920"/>
              <a:chOff x="8413920" y="4003560"/>
              <a:chExt cx="539640" cy="430920"/>
            </a:xfrm>
          </p:grpSpPr>
          <p:sp>
            <p:nvSpPr>
              <p:cNvPr id="279" name=""/>
              <p:cNvSpPr/>
              <p:nvPr/>
            </p:nvSpPr>
            <p:spPr>
              <a:xfrm>
                <a:off x="8413920" y="4003560"/>
                <a:ext cx="5396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</a:rPr>
                  <a:t>3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80" name=""/>
              <p:cNvGrpSpPr/>
              <p:nvPr/>
            </p:nvGrpSpPr>
            <p:grpSpPr>
              <a:xfrm>
                <a:off x="8505720" y="4134960"/>
                <a:ext cx="119160" cy="299520"/>
                <a:chOff x="8505720" y="4134960"/>
                <a:chExt cx="119160" cy="299520"/>
              </a:xfrm>
            </p:grpSpPr>
            <p:sp>
              <p:nvSpPr>
                <p:cNvPr id="281" name=""/>
                <p:cNvSpPr/>
                <p:nvPr/>
              </p:nvSpPr>
              <p:spPr>
                <a:xfrm flipV="1">
                  <a:off x="8505720" y="4218840"/>
                  <a:ext cx="0" cy="215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2" name=""/>
                <p:cNvSpPr/>
                <p:nvPr/>
              </p:nvSpPr>
              <p:spPr>
                <a:xfrm flipV="1">
                  <a:off x="8505720" y="4134960"/>
                  <a:ext cx="119160" cy="774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0600" bIns="30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283" name=""/>
            <p:cNvGrpSpPr/>
            <p:nvPr/>
          </p:nvGrpSpPr>
          <p:grpSpPr>
            <a:xfrm>
              <a:off x="8686800" y="4135320"/>
              <a:ext cx="119160" cy="300240"/>
              <a:chOff x="8686800" y="4135320"/>
              <a:chExt cx="119160" cy="300240"/>
            </a:xfrm>
          </p:grpSpPr>
          <p:sp>
            <p:nvSpPr>
              <p:cNvPr id="284" name=""/>
              <p:cNvSpPr/>
              <p:nvPr/>
            </p:nvSpPr>
            <p:spPr>
              <a:xfrm flipV="1">
                <a:off x="8686800" y="4219560"/>
                <a:ext cx="0" cy="21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"/>
              <p:cNvSpPr/>
              <p:nvPr/>
            </p:nvSpPr>
            <p:spPr>
              <a:xfrm flipV="1">
                <a:off x="8686800" y="4135320"/>
                <a:ext cx="11916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86" name=""/>
            <p:cNvGrpSpPr/>
            <p:nvPr/>
          </p:nvGrpSpPr>
          <p:grpSpPr>
            <a:xfrm>
              <a:off x="8845560" y="4135320"/>
              <a:ext cx="119160" cy="300240"/>
              <a:chOff x="8845560" y="4135320"/>
              <a:chExt cx="119160" cy="300240"/>
            </a:xfrm>
          </p:grpSpPr>
          <p:sp>
            <p:nvSpPr>
              <p:cNvPr id="287" name=""/>
              <p:cNvSpPr/>
              <p:nvPr/>
            </p:nvSpPr>
            <p:spPr>
              <a:xfrm flipV="1">
                <a:off x="8845560" y="4219560"/>
                <a:ext cx="0" cy="21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"/>
              <p:cNvSpPr/>
              <p:nvPr/>
            </p:nvSpPr>
            <p:spPr>
              <a:xfrm flipV="1">
                <a:off x="8845560" y="4135320"/>
                <a:ext cx="11916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89" name=""/>
            <p:cNvGrpSpPr/>
            <p:nvPr/>
          </p:nvGrpSpPr>
          <p:grpSpPr>
            <a:xfrm>
              <a:off x="3992400" y="3760920"/>
              <a:ext cx="1244520" cy="558720"/>
              <a:chOff x="3992400" y="3760920"/>
              <a:chExt cx="1244520" cy="558720"/>
            </a:xfrm>
          </p:grpSpPr>
          <p:sp>
            <p:nvSpPr>
              <p:cNvPr id="290" name=""/>
              <p:cNvSpPr/>
              <p:nvPr/>
            </p:nvSpPr>
            <p:spPr>
              <a:xfrm>
                <a:off x="4090680" y="4013280"/>
                <a:ext cx="0" cy="30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"/>
              <p:cNvSpPr/>
              <p:nvPr/>
            </p:nvSpPr>
            <p:spPr>
              <a:xfrm>
                <a:off x="3992400" y="3760920"/>
                <a:ext cx="1244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FAK-ATG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92" name=""/>
            <p:cNvGrpSpPr/>
            <p:nvPr/>
          </p:nvGrpSpPr>
          <p:grpSpPr>
            <a:xfrm>
              <a:off x="7477200" y="3770280"/>
              <a:ext cx="1244520" cy="558720"/>
              <a:chOff x="7477200" y="3770280"/>
              <a:chExt cx="1244520" cy="558720"/>
            </a:xfrm>
          </p:grpSpPr>
          <p:sp>
            <p:nvSpPr>
              <p:cNvPr id="293" name=""/>
              <p:cNvSpPr/>
              <p:nvPr/>
            </p:nvSpPr>
            <p:spPr>
              <a:xfrm>
                <a:off x="7575480" y="4022640"/>
                <a:ext cx="0" cy="30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"/>
              <p:cNvSpPr/>
              <p:nvPr/>
            </p:nvSpPr>
            <p:spPr>
              <a:xfrm>
                <a:off x="7477200" y="3770280"/>
                <a:ext cx="1244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FRNK-ATG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95" name=""/>
            <p:cNvGrpSpPr/>
            <p:nvPr/>
          </p:nvGrpSpPr>
          <p:grpSpPr>
            <a:xfrm>
              <a:off x="6308640" y="3990960"/>
              <a:ext cx="540000" cy="443520"/>
              <a:chOff x="6308640" y="3990960"/>
              <a:chExt cx="540000" cy="443520"/>
            </a:xfrm>
          </p:grpSpPr>
          <p:sp>
            <p:nvSpPr>
              <p:cNvPr id="296" name=""/>
              <p:cNvSpPr/>
              <p:nvPr/>
            </p:nvSpPr>
            <p:spPr>
              <a:xfrm>
                <a:off x="6308640" y="3990960"/>
                <a:ext cx="540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</a:rPr>
                  <a:t>16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97" name=""/>
              <p:cNvGrpSpPr/>
              <p:nvPr/>
            </p:nvGrpSpPr>
            <p:grpSpPr>
              <a:xfrm>
                <a:off x="6418440" y="4134960"/>
                <a:ext cx="118800" cy="299520"/>
                <a:chOff x="6418440" y="4134960"/>
                <a:chExt cx="118800" cy="299520"/>
              </a:xfrm>
            </p:grpSpPr>
            <p:sp>
              <p:nvSpPr>
                <p:cNvPr id="298" name=""/>
                <p:cNvSpPr/>
                <p:nvPr/>
              </p:nvSpPr>
              <p:spPr>
                <a:xfrm flipV="1">
                  <a:off x="6418440" y="4218840"/>
                  <a:ext cx="0" cy="215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9" name=""/>
                <p:cNvSpPr/>
                <p:nvPr/>
              </p:nvSpPr>
              <p:spPr>
                <a:xfrm flipV="1">
                  <a:off x="6418440" y="4134960"/>
                  <a:ext cx="118800" cy="774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0600" bIns="30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00" name=""/>
              <p:cNvSpPr/>
              <p:nvPr/>
            </p:nvSpPr>
            <p:spPr>
              <a:xfrm>
                <a:off x="6521400" y="4035240"/>
                <a:ext cx="117720" cy="1080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01" name=""/>
            <p:cNvSpPr/>
            <p:nvPr/>
          </p:nvSpPr>
          <p:spPr>
            <a:xfrm>
              <a:off x="6062760" y="3990960"/>
              <a:ext cx="539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1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02" name=""/>
            <p:cNvGrpSpPr/>
            <p:nvPr/>
          </p:nvGrpSpPr>
          <p:grpSpPr>
            <a:xfrm>
              <a:off x="6188040" y="4135320"/>
              <a:ext cx="119160" cy="300240"/>
              <a:chOff x="6188040" y="4135320"/>
              <a:chExt cx="119160" cy="300240"/>
            </a:xfrm>
          </p:grpSpPr>
          <p:sp>
            <p:nvSpPr>
              <p:cNvPr id="303" name=""/>
              <p:cNvSpPr/>
              <p:nvPr/>
            </p:nvSpPr>
            <p:spPr>
              <a:xfrm flipV="1">
                <a:off x="6188040" y="4219560"/>
                <a:ext cx="0" cy="21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"/>
              <p:cNvSpPr/>
              <p:nvPr/>
            </p:nvSpPr>
            <p:spPr>
              <a:xfrm flipV="1">
                <a:off x="6188040" y="4135320"/>
                <a:ext cx="11916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05" name=""/>
            <p:cNvSpPr/>
            <p:nvPr/>
          </p:nvSpPr>
          <p:spPr>
            <a:xfrm>
              <a:off x="6275520" y="4033800"/>
              <a:ext cx="117360" cy="1080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6041880" y="4357800"/>
              <a:ext cx="117720" cy="1080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3081240" y="4311720"/>
              <a:ext cx="301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-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1677960" y="4311720"/>
              <a:ext cx="301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-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453960" y="4311720"/>
              <a:ext cx="301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-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4370400" y="4313160"/>
              <a:ext cx="206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7107120" y="4503600"/>
              <a:ext cx="4352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…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7180200" y="2054160"/>
              <a:ext cx="4352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…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13" name=""/>
            <p:cNvGrpSpPr/>
            <p:nvPr/>
          </p:nvGrpSpPr>
          <p:grpSpPr>
            <a:xfrm>
              <a:off x="8342280" y="4313160"/>
              <a:ext cx="539640" cy="200520"/>
              <a:chOff x="8342280" y="4313160"/>
              <a:chExt cx="539640" cy="200520"/>
            </a:xfrm>
          </p:grpSpPr>
          <p:sp>
            <p:nvSpPr>
              <p:cNvPr id="314" name=""/>
              <p:cNvSpPr/>
              <p:nvPr/>
            </p:nvSpPr>
            <p:spPr>
              <a:xfrm>
                <a:off x="8342280" y="4313160"/>
                <a:ext cx="5396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</a:rPr>
                  <a:t>3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"/>
              <p:cNvSpPr/>
              <p:nvPr/>
            </p:nvSpPr>
            <p:spPr>
              <a:xfrm>
                <a:off x="8548560" y="4359240"/>
                <a:ext cx="117720" cy="1080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16" name=""/>
            <p:cNvGrpSpPr/>
            <p:nvPr/>
          </p:nvGrpSpPr>
          <p:grpSpPr>
            <a:xfrm>
              <a:off x="8396280" y="1816200"/>
              <a:ext cx="539640" cy="200520"/>
              <a:chOff x="8396280" y="1816200"/>
              <a:chExt cx="539640" cy="200520"/>
            </a:xfrm>
          </p:grpSpPr>
          <p:sp>
            <p:nvSpPr>
              <p:cNvPr id="317" name=""/>
              <p:cNvSpPr/>
              <p:nvPr/>
            </p:nvSpPr>
            <p:spPr>
              <a:xfrm>
                <a:off x="8396280" y="1816200"/>
                <a:ext cx="5396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</a:rPr>
                  <a:t>3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"/>
              <p:cNvSpPr/>
              <p:nvPr/>
            </p:nvSpPr>
            <p:spPr>
              <a:xfrm>
                <a:off x="8602560" y="1862280"/>
                <a:ext cx="117720" cy="1080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19" name=""/>
            <p:cNvSpPr/>
            <p:nvPr/>
          </p:nvSpPr>
          <p:spPr>
            <a:xfrm>
              <a:off x="2109960" y="4510080"/>
              <a:ext cx="0" cy="71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2073240" y="4511520"/>
              <a:ext cx="0" cy="714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 flipH="1">
              <a:off x="1577880" y="3997440"/>
              <a:ext cx="540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-2bM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2058840" y="4002120"/>
              <a:ext cx="540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-2aM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23" name=""/>
            <p:cNvGrpSpPr/>
            <p:nvPr/>
          </p:nvGrpSpPr>
          <p:grpSpPr>
            <a:xfrm>
              <a:off x="1955520" y="4141440"/>
              <a:ext cx="119160" cy="299520"/>
              <a:chOff x="1955520" y="4141440"/>
              <a:chExt cx="119160" cy="299520"/>
            </a:xfrm>
          </p:grpSpPr>
          <p:sp>
            <p:nvSpPr>
              <p:cNvPr id="324" name=""/>
              <p:cNvSpPr/>
              <p:nvPr/>
            </p:nvSpPr>
            <p:spPr>
              <a:xfrm flipV="1">
                <a:off x="2074680" y="4225320"/>
                <a:ext cx="0" cy="21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"/>
              <p:cNvSpPr/>
              <p:nvPr/>
            </p:nvSpPr>
            <p:spPr>
              <a:xfrm flipH="1" flipV="1">
                <a:off x="1955520" y="4141440"/>
                <a:ext cx="119160" cy="7740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26" name=""/>
            <p:cNvGrpSpPr/>
            <p:nvPr/>
          </p:nvGrpSpPr>
          <p:grpSpPr>
            <a:xfrm>
              <a:off x="2112840" y="4136760"/>
              <a:ext cx="119160" cy="299520"/>
              <a:chOff x="2112840" y="4136760"/>
              <a:chExt cx="119160" cy="299520"/>
            </a:xfrm>
          </p:grpSpPr>
          <p:sp>
            <p:nvSpPr>
              <p:cNvPr id="327" name=""/>
              <p:cNvSpPr/>
              <p:nvPr/>
            </p:nvSpPr>
            <p:spPr>
              <a:xfrm flipV="1">
                <a:off x="2112840" y="4220640"/>
                <a:ext cx="0" cy="21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"/>
              <p:cNvSpPr/>
              <p:nvPr/>
            </p:nvSpPr>
            <p:spPr>
              <a:xfrm flipV="1">
                <a:off x="2112840" y="4136760"/>
                <a:ext cx="119160" cy="7740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29" name=""/>
            <p:cNvSpPr/>
            <p:nvPr/>
          </p:nvSpPr>
          <p:spPr>
            <a:xfrm>
              <a:off x="189000" y="4565520"/>
              <a:ext cx="453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Arial"/>
                </a:rPr>
                <a:t>Prom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>
              <a:off x="162000" y="2101680"/>
              <a:ext cx="453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Arial"/>
                </a:rPr>
                <a:t>Prom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2455920" y="2004840"/>
              <a:ext cx="0" cy="744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2368440" y="200016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33" name=""/>
            <p:cNvGrpSpPr/>
            <p:nvPr/>
          </p:nvGrpSpPr>
          <p:grpSpPr>
            <a:xfrm>
              <a:off x="2452680" y="1649160"/>
              <a:ext cx="119160" cy="299520"/>
              <a:chOff x="2452680" y="1649160"/>
              <a:chExt cx="119160" cy="299520"/>
            </a:xfrm>
          </p:grpSpPr>
          <p:sp>
            <p:nvSpPr>
              <p:cNvPr id="334" name=""/>
              <p:cNvSpPr/>
              <p:nvPr/>
            </p:nvSpPr>
            <p:spPr>
              <a:xfrm flipV="1">
                <a:off x="2452680" y="1733040"/>
                <a:ext cx="0" cy="21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"/>
              <p:cNvSpPr/>
              <p:nvPr/>
            </p:nvSpPr>
            <p:spPr>
              <a:xfrm flipV="1">
                <a:off x="2452680" y="1649160"/>
                <a:ext cx="119160" cy="7740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36" name=""/>
            <p:cNvGrpSpPr/>
            <p:nvPr/>
          </p:nvGrpSpPr>
          <p:grpSpPr>
            <a:xfrm>
              <a:off x="2249640" y="1647720"/>
              <a:ext cx="118800" cy="300240"/>
              <a:chOff x="2249640" y="1647720"/>
              <a:chExt cx="118800" cy="300240"/>
            </a:xfrm>
          </p:grpSpPr>
          <p:sp>
            <p:nvSpPr>
              <p:cNvPr id="337" name=""/>
              <p:cNvSpPr/>
              <p:nvPr/>
            </p:nvSpPr>
            <p:spPr>
              <a:xfrm flipV="1">
                <a:off x="2368440" y="1731960"/>
                <a:ext cx="0" cy="21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"/>
              <p:cNvSpPr/>
              <p:nvPr/>
            </p:nvSpPr>
            <p:spPr>
              <a:xfrm flipH="1" flipV="1">
                <a:off x="2249640" y="1647720"/>
                <a:ext cx="11880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39" name=""/>
            <p:cNvSpPr/>
            <p:nvPr/>
          </p:nvSpPr>
          <p:spPr>
            <a:xfrm>
              <a:off x="2444760" y="1512720"/>
              <a:ext cx="431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-2aH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1922400" y="1512720"/>
              <a:ext cx="432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-2bH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>
              <a:off x="942840" y="2008080"/>
              <a:ext cx="0" cy="74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42" name=""/>
            <p:cNvGrpSpPr/>
            <p:nvPr/>
          </p:nvGrpSpPr>
          <p:grpSpPr>
            <a:xfrm>
              <a:off x="941400" y="1650960"/>
              <a:ext cx="119160" cy="300240"/>
              <a:chOff x="941400" y="1650960"/>
              <a:chExt cx="119160" cy="300240"/>
            </a:xfrm>
          </p:grpSpPr>
          <p:sp>
            <p:nvSpPr>
              <p:cNvPr id="343" name=""/>
              <p:cNvSpPr/>
              <p:nvPr/>
            </p:nvSpPr>
            <p:spPr>
              <a:xfrm flipV="1">
                <a:off x="941400" y="1735200"/>
                <a:ext cx="0" cy="21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"/>
              <p:cNvSpPr/>
              <p:nvPr/>
            </p:nvSpPr>
            <p:spPr>
              <a:xfrm flipV="1">
                <a:off x="941400" y="1650960"/>
                <a:ext cx="11916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45" name=""/>
            <p:cNvGrpSpPr/>
            <p:nvPr/>
          </p:nvGrpSpPr>
          <p:grpSpPr>
            <a:xfrm>
              <a:off x="824040" y="1649160"/>
              <a:ext cx="118800" cy="299520"/>
              <a:chOff x="824040" y="1649160"/>
              <a:chExt cx="118800" cy="299520"/>
            </a:xfrm>
          </p:grpSpPr>
          <p:sp>
            <p:nvSpPr>
              <p:cNvPr id="346" name=""/>
              <p:cNvSpPr/>
              <p:nvPr/>
            </p:nvSpPr>
            <p:spPr>
              <a:xfrm flipV="1">
                <a:off x="942840" y="1733040"/>
                <a:ext cx="0" cy="21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"/>
              <p:cNvSpPr/>
              <p:nvPr/>
            </p:nvSpPr>
            <p:spPr>
              <a:xfrm flipH="1" flipV="1">
                <a:off x="824040" y="1649160"/>
                <a:ext cx="118800" cy="7740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48" name=""/>
            <p:cNvSpPr/>
            <p:nvPr/>
          </p:nvSpPr>
          <p:spPr>
            <a:xfrm>
              <a:off x="933480" y="1514520"/>
              <a:ext cx="431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-3aH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496800" y="1514520"/>
              <a:ext cx="432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-3bH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7096320" y="4581360"/>
              <a:ext cx="453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Arial"/>
                </a:rPr>
                <a:t>Prom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7183800" y="2131920"/>
              <a:ext cx="453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Arial"/>
                </a:rPr>
                <a:t>Prom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4557600" y="4314960"/>
              <a:ext cx="206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5361120" y="4309920"/>
              <a:ext cx="204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6-10T14:42:36Z</dcterms:created>
  <dc:creator>henslen</dc:creator>
  <dc:description/>
  <dc:language>en-US</dc:language>
  <cp:lastModifiedBy>henslen</cp:lastModifiedBy>
  <dcterms:modified xsi:type="dcterms:W3CDTF">2006-06-14T10:17:08Z</dcterms:modified>
  <cp:revision>6</cp:revision>
  <dc:subject/>
  <dc:title>Diapositive 1</dc:title>
</cp:coreProperties>
</file>